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43" d="100"/>
          <a:sy n="43" d="100"/>
        </p:scale>
        <p:origin x="228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36435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31174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26519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25630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12147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23614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2335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09294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07492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41682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69811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3E0C7-90B6-45DD-8FA0-C9666EA25435}" type="datetimeFigureOut">
              <a:rPr lang="nb-NO" smtClean="0"/>
              <a:t>31.0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A2BD3-B667-49AA-9CD9-0164FC3EE7B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65937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63538" y="1449508"/>
            <a:ext cx="5960122" cy="5216813"/>
            <a:chOff x="463538" y="1449508"/>
            <a:chExt cx="5960122" cy="5216813"/>
          </a:xfrm>
        </p:grpSpPr>
        <p:grpSp>
          <p:nvGrpSpPr>
            <p:cNvPr id="15" name="Group 14"/>
            <p:cNvGrpSpPr/>
            <p:nvPr/>
          </p:nvGrpSpPr>
          <p:grpSpPr>
            <a:xfrm>
              <a:off x="463538" y="1449508"/>
              <a:ext cx="5960122" cy="5216813"/>
              <a:chOff x="-697360" y="1661806"/>
              <a:chExt cx="5960122" cy="5216813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-697360" y="2778091"/>
                <a:ext cx="1296559" cy="2723823"/>
              </a:xfrm>
              <a:prstGeom prst="rect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1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rognostic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value</a:t>
                </a:r>
                <a:endParaRPr kumimoji="0" lang="nb-NO" sz="9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Search</a:t>
                </a: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terms </a:t>
                </a:r>
                <a:r>
                  <a:rPr kumimoji="0" lang="nb-NO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ombined</a:t>
                </a: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with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"OR":</a:t>
                </a:r>
                <a:endPara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rognosis.m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  <a:endPara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rognosis adj3 factor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  <a:endPara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rognosis/ 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rognostic adj3 factor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isease-free survival/ or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Survival Analysis/ or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Survival/ or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Survival Rate/ </a:t>
                </a:r>
                <a:endPara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Recurrence/ or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Neoplasm Recurrence, Local/ </a:t>
                </a:r>
                <a:endPara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eath/ or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"Cause of Death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"/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133072" y="1661806"/>
                <a:ext cx="2224690" cy="5216813"/>
              </a:xfrm>
              <a:prstGeom prst="rect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2 Immune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s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(mast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s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,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atural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killer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s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,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acrophages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,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lymphocytes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,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endritic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s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)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Search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terms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ombined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with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"OR</a:t>
                </a: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":</a:t>
                </a:r>
                <a:endParaRPr kumimoji="0" lang="en-US" sz="9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ast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s/ or myeloid 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s/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ast Cells/ </a:t>
                </a: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Killer Cells, Natural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/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atural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killer cell.mp. or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Killer Cells, Natural/ 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acrophage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acrophages/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acrophages.m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or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Macrophages/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umor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adj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microenvironment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ancer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adj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microenvironment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umor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infiltrating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adj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lymphocytes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).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de-DE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lymphocyte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.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  <a:endParaRPr kumimoji="0" lang="de-DE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de-DE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de-DE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lymphocyte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/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de-DE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de-DE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umor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infiltrating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lymphocytes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/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de-DE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de-DE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umor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icroenvironment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/ </a:t>
                </a:r>
                <a:r>
                  <a:rPr kumimoji="0" lang="de-DE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 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de-DE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.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de-DE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de-DE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de-DE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b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lymphocyte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/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de-DE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b 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lymphocyte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.</a:t>
                </a:r>
                <a:r>
                  <a:rPr kumimoji="0" lang="de-DE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de-DE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b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.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immune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.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immune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infiltrate.ti,ab,kw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endritic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s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/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endritic</a:t>
                </a: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.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antigen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resenting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/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antigen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resenting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ell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.</a:t>
                </a:r>
                <a:r>
                  <a:rPr kumimoji="0" lang="nb-NO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high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ndothelial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venule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tertiary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adj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lymphoid structure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ctopic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lymphoid tissue*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ctopic 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adj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lymphoid organ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3891635" y="2778091"/>
                <a:ext cx="1371127" cy="2723823"/>
              </a:xfrm>
              <a:prstGeom prst="rect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900" b="1" i="0" u="none" strike="noStrike" kern="1200" cap="none" spc="0" normalizeH="0" baseline="0" noProof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3 </a:t>
                </a: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Oral cancer 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Search</a:t>
                </a: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erms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ombined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with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"OR</a:t>
                </a: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":</a:t>
                </a:r>
                <a:endParaRPr kumimoji="0" lang="en-US" sz="9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outh neoplasms/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oral adj3 carcinoma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oral adj3 cancer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outh adj3 cancer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nb-NO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oral adj3 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eoplasm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*).</a:t>
                </a:r>
                <a:r>
                  <a:rPr kumimoji="0" lang="nb-NO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nb-NO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xp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head/ and neck neoplasms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/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head adj3 neck adj4 cancer*).</a:t>
                </a:r>
                <a:r>
                  <a:rPr kumimoji="0" lang="en-US" sz="9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 </a:t>
                </a:r>
              </a:p>
              <a:p>
                <a:pPr marL="171450" marR="0" lvl="0" indent="-1714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Char char="-"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head adj3 neck adj4 carcinoma*).</a:t>
                </a: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i,ab,kw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3422230" y="4093836"/>
                <a:ext cx="404937" cy="230832"/>
              </a:xfrm>
              <a:prstGeom prst="rect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nb-NO" sz="9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AND</a:t>
                </a:r>
                <a:endParaRPr kumimoji="0" 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sp>
          <p:nvSpPr>
            <p:cNvPr id="10" name="TextBox 12"/>
            <p:cNvSpPr txBox="1"/>
            <p:nvPr/>
          </p:nvSpPr>
          <p:spPr>
            <a:xfrm>
              <a:off x="1824565" y="3881538"/>
              <a:ext cx="404937" cy="230832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nb-NO" sz="9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ND</a:t>
              </a:r>
              <a:endPara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3" name="Rectangle 2"/>
          <p:cNvSpPr/>
          <p:nvPr/>
        </p:nvSpPr>
        <p:spPr>
          <a:xfrm>
            <a:off x="451986" y="9354355"/>
            <a:ext cx="5908658" cy="1328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</a:t>
            </a:r>
            <a:endParaRPr lang="nb-NO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arch strategy for this systematic review of studies reporting the prognostic value of selected immune cells in oral cancer.</a:t>
            </a:r>
            <a:endParaRPr lang="nb-NO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21475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0</Words>
  <Application>Microsoft Office PowerPoint</Application>
  <PresentationFormat>Widescreen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iT Norges arktiske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n Synnøve Hadler-Olsen</dc:creator>
  <cp:lastModifiedBy>Elin Synnøve Hadler-Olsen</cp:lastModifiedBy>
  <cp:revision>2</cp:revision>
  <dcterms:created xsi:type="dcterms:W3CDTF">2018-09-09T10:01:27Z</dcterms:created>
  <dcterms:modified xsi:type="dcterms:W3CDTF">2019-01-31T13:17:27Z</dcterms:modified>
</cp:coreProperties>
</file>